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72183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3" d="100"/>
          <a:sy n="103" d="100"/>
        </p:scale>
        <p:origin x="8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J:\SSR41data\FiguresAndTables\Supplementary%20Figure3\&#30775;&#22788;&#29702;&#25968;&#25454;&#27979;&#37327;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J:\SSR41data\FiguresAndTables\Supplementary%20Figure3\&#30775;&#22788;&#29702;&#25968;&#25454;&#27979;&#37327;.xls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Yugu1</c:f>
              <c:strCache>
                <c:ptCount val="1"/>
                <c:pt idx="0">
                  <c:v>Yugu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根长作图!$D$2:$D$6</c:f>
                <c:numCache>
                  <c:formatCode>General</c:formatCode>
                  <c:ptCount val="5"/>
                  <c:pt idx="0">
                    <c:v>0.22336</c:v>
                  </c:pt>
                  <c:pt idx="1">
                    <c:v>0.29536499999999999</c:v>
                  </c:pt>
                  <c:pt idx="2">
                    <c:v>0.13488</c:v>
                  </c:pt>
                  <c:pt idx="3">
                    <c:v>0.31075000000000003</c:v>
                  </c:pt>
                  <c:pt idx="4">
                    <c:v>0.18975</c:v>
                  </c:pt>
                </c:numCache>
              </c:numRef>
            </c:plus>
            <c:minus>
              <c:numRef>
                <c:f>根长作图!$D$2:$D$6</c:f>
                <c:numCache>
                  <c:formatCode>General</c:formatCode>
                  <c:ptCount val="5"/>
                  <c:pt idx="0">
                    <c:v>0.22336</c:v>
                  </c:pt>
                  <c:pt idx="1">
                    <c:v>0.29536499999999999</c:v>
                  </c:pt>
                  <c:pt idx="2">
                    <c:v>0.13488</c:v>
                  </c:pt>
                  <c:pt idx="3">
                    <c:v>0.31075000000000003</c:v>
                  </c:pt>
                  <c:pt idx="4">
                    <c:v>0.1897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根长作图!$A$2:$A$6</c:f>
              <c:strCache>
                <c:ptCount val="5"/>
                <c:pt idx="0">
                  <c:v>0 μM</c:v>
                </c:pt>
                <c:pt idx="1">
                  <c:v>5 μM</c:v>
                </c:pt>
                <c:pt idx="2">
                  <c:v>10 μM</c:v>
                </c:pt>
                <c:pt idx="3">
                  <c:v>20 μM</c:v>
                </c:pt>
                <c:pt idx="4">
                  <c:v>40 μM</c:v>
                </c:pt>
              </c:strCache>
            </c:strRef>
          </c:cat>
          <c:val>
            <c:numRef>
              <c:f>根长作图!$B$2:$B$6</c:f>
              <c:numCache>
                <c:formatCode>General</c:formatCode>
                <c:ptCount val="5"/>
                <c:pt idx="0">
                  <c:v>3.49</c:v>
                </c:pt>
                <c:pt idx="1">
                  <c:v>3.0449999999999999</c:v>
                </c:pt>
                <c:pt idx="2">
                  <c:v>2.81</c:v>
                </c:pt>
                <c:pt idx="3">
                  <c:v>2.8250000000000002</c:v>
                </c:pt>
                <c:pt idx="4">
                  <c:v>2.52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FD-4C36-B748-C3A46020A914}"/>
            </c:ext>
          </c:extLst>
        </c:ser>
        <c:ser>
          <c:idx val="1"/>
          <c:order val="1"/>
          <c:tx>
            <c:strRef>
              <c:f>siwls1</c:f>
              <c:strCache>
                <c:ptCount val="1"/>
                <c:pt idx="0">
                  <c:v>siwls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根长作图!$E$2:$E$6</c:f>
                <c:numCache>
                  <c:formatCode>General</c:formatCode>
                  <c:ptCount val="5"/>
                  <c:pt idx="0">
                    <c:v>0.34897499999999998</c:v>
                  </c:pt>
                  <c:pt idx="1">
                    <c:v>0.12470000000000001</c:v>
                  </c:pt>
                  <c:pt idx="2">
                    <c:v>0.16489999999999999</c:v>
                  </c:pt>
                  <c:pt idx="3">
                    <c:v>0.15345</c:v>
                  </c:pt>
                  <c:pt idx="4">
                    <c:v>4.0875000000000002E-2</c:v>
                  </c:pt>
                </c:numCache>
              </c:numRef>
            </c:plus>
            <c:minus>
              <c:numRef>
                <c:f>根长作图!$E$2:$E$6</c:f>
                <c:numCache>
                  <c:formatCode>General</c:formatCode>
                  <c:ptCount val="5"/>
                  <c:pt idx="0">
                    <c:v>0.34897499999999998</c:v>
                  </c:pt>
                  <c:pt idx="1">
                    <c:v>0.12470000000000001</c:v>
                  </c:pt>
                  <c:pt idx="2">
                    <c:v>0.16489999999999999</c:v>
                  </c:pt>
                  <c:pt idx="3">
                    <c:v>0.15345</c:v>
                  </c:pt>
                  <c:pt idx="4">
                    <c:v>4.0875000000000002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根长作图!$A$2:$A$6</c:f>
              <c:strCache>
                <c:ptCount val="5"/>
                <c:pt idx="0">
                  <c:v>0 μM</c:v>
                </c:pt>
                <c:pt idx="1">
                  <c:v>5 μM</c:v>
                </c:pt>
                <c:pt idx="2">
                  <c:v>10 μM</c:v>
                </c:pt>
                <c:pt idx="3">
                  <c:v>20 μM</c:v>
                </c:pt>
                <c:pt idx="4">
                  <c:v>40 μM</c:v>
                </c:pt>
              </c:strCache>
            </c:strRef>
          </c:cat>
          <c:val>
            <c:numRef>
              <c:f>根长作图!$C$2:$C$6</c:f>
              <c:numCache>
                <c:formatCode>General</c:formatCode>
                <c:ptCount val="5"/>
                <c:pt idx="0">
                  <c:v>3.5249999999999999</c:v>
                </c:pt>
                <c:pt idx="1">
                  <c:v>2.15</c:v>
                </c:pt>
                <c:pt idx="2">
                  <c:v>1.94</c:v>
                </c:pt>
                <c:pt idx="3">
                  <c:v>1.55</c:v>
                </c:pt>
                <c:pt idx="4">
                  <c:v>0.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FD-4C36-B748-C3A46020A9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0"/>
        <c:overlap val="-19"/>
        <c:axId val="721064216"/>
        <c:axId val="721065200"/>
      </c:barChart>
      <c:catAx>
        <c:axId val="721064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zh-CN"/>
          </a:p>
        </c:txPr>
        <c:crossAx val="721065200"/>
        <c:crosses val="autoZero"/>
        <c:auto val="1"/>
        <c:lblAlgn val="ctr"/>
        <c:lblOffset val="100"/>
        <c:noMultiLvlLbl val="0"/>
      </c:catAx>
      <c:valAx>
        <c:axId val="721065200"/>
        <c:scaling>
          <c:orientation val="minMax"/>
          <c:max val="4.5999999999999996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zh-CN"/>
          </a:p>
        </c:txPr>
        <c:crossAx val="721064216"/>
        <c:crosses val="autoZero"/>
        <c:crossBetween val="between"/>
        <c:majorUnit val="1"/>
        <c:minorUnit val="0.5"/>
      </c:valAx>
      <c:spPr>
        <a:noFill/>
        <a:ln w="19050">
          <a:solidFill>
            <a:schemeClr val="tx1"/>
          </a:solidFill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lang="zh-CN"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zh-CN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lang="zh-CN" sz="12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zh-CN"/>
          </a:p>
        </c:txPr>
      </c:legendEntry>
      <c:layout>
        <c:manualLayout>
          <c:xMode val="edge"/>
          <c:yMode val="edge"/>
          <c:x val="0.78628433785813301"/>
          <c:y val="6.7366292328213104E-2"/>
          <c:w val="0.17339417581943001"/>
          <c:h val="0.128368544095921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  <a:sym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 sz="1400">
          <a:solidFill>
            <a:sysClr val="windowText" lastClr="000000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Yugu1</c:f>
              <c:strCache>
                <c:ptCount val="1"/>
                <c:pt idx="0">
                  <c:v>Yugu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苗长作图 (2)'!$D$2:$D$6</c:f>
                <c:numCache>
                  <c:formatCode>General</c:formatCode>
                  <c:ptCount val="5"/>
                  <c:pt idx="0">
                    <c:v>0.206625</c:v>
                  </c:pt>
                  <c:pt idx="1">
                    <c:v>0.110925</c:v>
                  </c:pt>
                  <c:pt idx="2">
                    <c:v>8.2059999999999994E-2</c:v>
                  </c:pt>
                  <c:pt idx="3">
                    <c:v>7.7850000000000003E-2</c:v>
                  </c:pt>
                  <c:pt idx="4">
                    <c:v>0.14352000000000001</c:v>
                  </c:pt>
                </c:numCache>
              </c:numRef>
            </c:plus>
            <c:minus>
              <c:numRef>
                <c:f>'苗长作图 (2)'!$D$2:$D$6</c:f>
                <c:numCache>
                  <c:formatCode>General</c:formatCode>
                  <c:ptCount val="5"/>
                  <c:pt idx="0">
                    <c:v>0.206625</c:v>
                  </c:pt>
                  <c:pt idx="1">
                    <c:v>0.110925</c:v>
                  </c:pt>
                  <c:pt idx="2">
                    <c:v>8.2059999999999994E-2</c:v>
                  </c:pt>
                  <c:pt idx="3">
                    <c:v>7.7850000000000003E-2</c:v>
                  </c:pt>
                  <c:pt idx="4">
                    <c:v>0.1435200000000000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苗长作图 (2)'!$A$2:$A$6</c:f>
              <c:strCache>
                <c:ptCount val="5"/>
                <c:pt idx="0">
                  <c:v>0 μM</c:v>
                </c:pt>
                <c:pt idx="1">
                  <c:v>5 μM</c:v>
                </c:pt>
                <c:pt idx="2">
                  <c:v>10 μM</c:v>
                </c:pt>
                <c:pt idx="3">
                  <c:v>20 μM</c:v>
                </c:pt>
                <c:pt idx="4">
                  <c:v>40 μM</c:v>
                </c:pt>
              </c:strCache>
            </c:strRef>
          </c:cat>
          <c:val>
            <c:numRef>
              <c:f>'苗长作图 (2)'!$B$2:$B$6</c:f>
              <c:numCache>
                <c:formatCode>General</c:formatCode>
                <c:ptCount val="5"/>
                <c:pt idx="0">
                  <c:v>2.375</c:v>
                </c:pt>
                <c:pt idx="1">
                  <c:v>2.1749999999999998</c:v>
                </c:pt>
                <c:pt idx="2">
                  <c:v>1.865</c:v>
                </c:pt>
                <c:pt idx="3">
                  <c:v>1.73</c:v>
                </c:pt>
                <c:pt idx="4">
                  <c:v>1.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145-4DC0-8624-B8E4DE63CF27}"/>
            </c:ext>
          </c:extLst>
        </c:ser>
        <c:ser>
          <c:idx val="1"/>
          <c:order val="1"/>
          <c:tx>
            <c:strRef>
              <c:f>siwls1</c:f>
              <c:strCache>
                <c:ptCount val="1"/>
                <c:pt idx="0">
                  <c:v>siwls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苗长作图 (2)'!$E$2:$E$6</c:f>
                <c:numCache>
                  <c:formatCode>General</c:formatCode>
                  <c:ptCount val="5"/>
                  <c:pt idx="0">
                    <c:v>0.2366</c:v>
                  </c:pt>
                  <c:pt idx="1">
                    <c:v>0.16059999999999999</c:v>
                  </c:pt>
                  <c:pt idx="2">
                    <c:v>0.1232</c:v>
                  </c:pt>
                  <c:pt idx="3">
                    <c:v>0.15190000000000001</c:v>
                  </c:pt>
                  <c:pt idx="4">
                    <c:v>7.0949999999999999E-2</c:v>
                  </c:pt>
                </c:numCache>
              </c:numRef>
            </c:plus>
            <c:minus>
              <c:numRef>
                <c:f>'苗长作图 (2)'!$E$2:$E$6</c:f>
                <c:numCache>
                  <c:formatCode>General</c:formatCode>
                  <c:ptCount val="5"/>
                  <c:pt idx="0">
                    <c:v>0.2366</c:v>
                  </c:pt>
                  <c:pt idx="1">
                    <c:v>0.16059999999999999</c:v>
                  </c:pt>
                  <c:pt idx="2">
                    <c:v>0.1232</c:v>
                  </c:pt>
                  <c:pt idx="3">
                    <c:v>0.15190000000000001</c:v>
                  </c:pt>
                  <c:pt idx="4">
                    <c:v>7.0949999999999999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苗长作图 (2)'!$A$2:$A$6</c:f>
              <c:strCache>
                <c:ptCount val="5"/>
                <c:pt idx="0">
                  <c:v>0 μM</c:v>
                </c:pt>
                <c:pt idx="1">
                  <c:v>5 μM</c:v>
                </c:pt>
                <c:pt idx="2">
                  <c:v>10 μM</c:v>
                </c:pt>
                <c:pt idx="3">
                  <c:v>20 μM</c:v>
                </c:pt>
                <c:pt idx="4">
                  <c:v>40 μM</c:v>
                </c:pt>
              </c:strCache>
            </c:strRef>
          </c:cat>
          <c:val>
            <c:numRef>
              <c:f>'苗长作图 (2)'!$C$2:$C$6</c:f>
              <c:numCache>
                <c:formatCode>General</c:formatCode>
                <c:ptCount val="5"/>
                <c:pt idx="0">
                  <c:v>2.2749999999999999</c:v>
                </c:pt>
                <c:pt idx="1">
                  <c:v>1.825</c:v>
                </c:pt>
                <c:pt idx="2">
                  <c:v>1.6</c:v>
                </c:pt>
                <c:pt idx="3">
                  <c:v>1.55</c:v>
                </c:pt>
                <c:pt idx="4">
                  <c:v>1.0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145-4DC0-8624-B8E4DE63CF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0"/>
        <c:overlap val="-19"/>
        <c:axId val="721064216"/>
        <c:axId val="721065200"/>
      </c:barChart>
      <c:catAx>
        <c:axId val="721064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721065200"/>
        <c:crosses val="autoZero"/>
        <c:auto val="1"/>
        <c:lblAlgn val="ctr"/>
        <c:lblOffset val="100"/>
        <c:noMultiLvlLbl val="0"/>
      </c:catAx>
      <c:valAx>
        <c:axId val="721065200"/>
        <c:scaling>
          <c:orientation val="minMax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721064216"/>
        <c:crosses val="autoZero"/>
        <c:crossBetween val="between"/>
        <c:majorUnit val="1"/>
        <c:minorUnit val="0.5"/>
      </c:valAx>
      <c:spPr>
        <a:noFill/>
        <a:ln w="19050">
          <a:solidFill>
            <a:schemeClr val="tx1"/>
          </a:solidFill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lang="zh-CN" sz="12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</c:legendEntry>
      <c:layout>
        <c:manualLayout>
          <c:xMode val="edge"/>
          <c:yMode val="edge"/>
          <c:x val="0.78628433785813301"/>
          <c:y val="6.7366292328213104E-2"/>
          <c:w val="0.17339417581943001"/>
          <c:h val="0.128368544095921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81339"/>
            <a:ext cx="9144000" cy="251306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791312"/>
            <a:ext cx="9144000" cy="1742766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84311"/>
            <a:ext cx="2628900" cy="611722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84311"/>
            <a:ext cx="7734300" cy="611722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99579"/>
            <a:ext cx="10515600" cy="300263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830623"/>
            <a:ext cx="10515600" cy="157901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921555"/>
            <a:ext cx="5181600" cy="45799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921555"/>
            <a:ext cx="5181600" cy="45799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84311"/>
            <a:ext cx="10515600" cy="13952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769502"/>
            <a:ext cx="5157787" cy="86720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636707"/>
            <a:ext cx="5157787" cy="387820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769502"/>
            <a:ext cx="5183188" cy="86720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636707"/>
            <a:ext cx="5183188" cy="387820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81224"/>
            <a:ext cx="3932237" cy="168428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039311"/>
            <a:ext cx="6172200" cy="512971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65509"/>
            <a:ext cx="3932237" cy="401187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81224"/>
            <a:ext cx="3932237" cy="168428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039311"/>
            <a:ext cx="6172200" cy="5129716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65509"/>
            <a:ext cx="3932237" cy="401187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84311"/>
            <a:ext cx="10515600" cy="139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921555"/>
            <a:ext cx="10515600" cy="45799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690354"/>
            <a:ext cx="2743200" cy="3843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9378E-2BED-451E-987B-CAD150509F7B}" type="datetimeFigureOut">
              <a:rPr lang="zh-CN" altLang="en-US" smtClean="0"/>
              <a:t>2021/7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690354"/>
            <a:ext cx="4114800" cy="3843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690354"/>
            <a:ext cx="2743200" cy="3843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228AE-41D7-47DD-898C-9B5FA9D84B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组合 25">
            <a:extLst>
              <a:ext uri="{FF2B5EF4-FFF2-40B4-BE49-F238E27FC236}">
                <a16:creationId xmlns:a16="http://schemas.microsoft.com/office/drawing/2014/main" id="{A07E282B-C540-49F6-9F62-C0D9D13A3BC4}"/>
              </a:ext>
            </a:extLst>
          </p:cNvPr>
          <p:cNvGrpSpPr/>
          <p:nvPr/>
        </p:nvGrpSpPr>
        <p:grpSpPr>
          <a:xfrm>
            <a:off x="-8255" y="-49260"/>
            <a:ext cx="12192000" cy="7224356"/>
            <a:chOff x="-8255" y="-49260"/>
            <a:chExt cx="12192000" cy="7224356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8255" y="-49260"/>
              <a:ext cx="12192000" cy="3799819"/>
            </a:xfrm>
            <a:prstGeom prst="rect">
              <a:avLst/>
            </a:prstGeom>
          </p:spPr>
        </p:pic>
        <p:graphicFrame>
          <p:nvGraphicFramePr>
            <p:cNvPr id="6" name="图表 5"/>
            <p:cNvGraphicFramePr/>
            <p:nvPr>
              <p:extLst>
                <p:ext uri="{D42A27DB-BD31-4B8C-83A1-F6EECF244321}">
                  <p14:modId xmlns:p14="http://schemas.microsoft.com/office/powerpoint/2010/main" val="1155297579"/>
                </p:ext>
              </p:extLst>
            </p:nvPr>
          </p:nvGraphicFramePr>
          <p:xfrm>
            <a:off x="1294130" y="4115048"/>
            <a:ext cx="4652010" cy="305814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图表 6"/>
            <p:cNvGraphicFramePr/>
            <p:nvPr>
              <p:extLst>
                <p:ext uri="{D42A27DB-BD31-4B8C-83A1-F6EECF244321}">
                  <p14:modId xmlns:p14="http://schemas.microsoft.com/office/powerpoint/2010/main" val="605928929"/>
                </p:ext>
              </p:extLst>
            </p:nvPr>
          </p:nvGraphicFramePr>
          <p:xfrm>
            <a:off x="6441440" y="4116953"/>
            <a:ext cx="4705350" cy="305814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" name="文本框 1"/>
            <p:cNvSpPr txBox="1"/>
            <p:nvPr/>
          </p:nvSpPr>
          <p:spPr>
            <a:xfrm>
              <a:off x="255905" y="-7985"/>
              <a:ext cx="687705" cy="306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ugu1</a:t>
              </a:r>
              <a:endParaRPr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2741930" y="-2270"/>
              <a:ext cx="692785" cy="3079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ugu1</a:t>
              </a:r>
              <a:endParaRPr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5285105" y="-5445"/>
              <a:ext cx="692785" cy="3079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ugu1</a:t>
              </a:r>
              <a:endParaRPr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7643495" y="-2270"/>
              <a:ext cx="692785" cy="3079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ugu1</a:t>
              </a:r>
              <a:endParaRPr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0306685" y="-6715"/>
              <a:ext cx="692785" cy="3079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ugu1</a:t>
              </a:r>
              <a:endParaRPr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421130" y="12335"/>
              <a:ext cx="666750" cy="306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wls1</a:t>
              </a:r>
              <a:endParaRPr lang="zh-CN" altLang="en-US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3928745" y="23130"/>
              <a:ext cx="666750" cy="306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wls1</a:t>
              </a:r>
              <a:endParaRPr lang="zh-CN" altLang="en-US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6437630" y="26305"/>
              <a:ext cx="666750" cy="306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wls1</a:t>
              </a:r>
              <a:endParaRPr lang="zh-CN" altLang="en-US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8793480" y="27575"/>
              <a:ext cx="666750" cy="306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wls1</a:t>
              </a:r>
              <a:endParaRPr lang="zh-CN" altLang="en-US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11287125" y="31385"/>
              <a:ext cx="666750" cy="306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wls1</a:t>
              </a:r>
              <a:endParaRPr lang="zh-CN" altLang="en-US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 rot="10800000">
              <a:off x="907415" y="4371586"/>
              <a:ext cx="431165" cy="179894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Root length (cm)</a:t>
              </a:r>
            </a:p>
          </p:txBody>
        </p:sp>
        <p:sp>
          <p:nvSpPr>
            <p:cNvPr id="18" name="文本框 17"/>
            <p:cNvSpPr txBox="1"/>
            <p:nvPr/>
          </p:nvSpPr>
          <p:spPr>
            <a:xfrm rot="10800000">
              <a:off x="6083300" y="4508745"/>
              <a:ext cx="431165" cy="167575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Plant height (cm)</a:t>
              </a: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698500" y="3735955"/>
              <a:ext cx="1000125" cy="3682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3130550" y="3739130"/>
              <a:ext cx="1047750" cy="369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As</a:t>
              </a: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5524500" y="3751829"/>
              <a:ext cx="1171575" cy="3682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US" altLang="zh-CN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As</a:t>
              </a: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8042275" y="3735955"/>
              <a:ext cx="1381760" cy="3682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altLang="zh-CN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As</a:t>
              </a: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0493375" y="3720080"/>
              <a:ext cx="1419225" cy="3682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 As</a:t>
              </a:r>
            </a:p>
          </p:txBody>
        </p:sp>
        <p:cxnSp>
          <p:nvCxnSpPr>
            <p:cNvPr id="29" name="直接连接符 28"/>
            <p:cNvCxnSpPr/>
            <p:nvPr/>
          </p:nvCxnSpPr>
          <p:spPr>
            <a:xfrm>
              <a:off x="1988515" y="4492625"/>
              <a:ext cx="323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29"/>
            <p:cNvCxnSpPr/>
            <p:nvPr/>
          </p:nvCxnSpPr>
          <p:spPr>
            <a:xfrm>
              <a:off x="1993595" y="4497705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30"/>
            <p:cNvCxnSpPr/>
            <p:nvPr/>
          </p:nvCxnSpPr>
          <p:spPr>
            <a:xfrm>
              <a:off x="2308555" y="4487545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/>
            <p:cNvCxnSpPr/>
            <p:nvPr/>
          </p:nvCxnSpPr>
          <p:spPr>
            <a:xfrm>
              <a:off x="2720975" y="4699635"/>
              <a:ext cx="323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/>
          </p:nvCxnSpPr>
          <p:spPr>
            <a:xfrm>
              <a:off x="2726055" y="4704715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4"/>
            <p:cNvCxnSpPr/>
            <p:nvPr/>
          </p:nvCxnSpPr>
          <p:spPr>
            <a:xfrm>
              <a:off x="3041015" y="4694555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/>
            <p:cNvCxnSpPr/>
            <p:nvPr/>
          </p:nvCxnSpPr>
          <p:spPr>
            <a:xfrm>
              <a:off x="3533775" y="4874260"/>
              <a:ext cx="323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/>
            <p:cNvCxnSpPr/>
            <p:nvPr/>
          </p:nvCxnSpPr>
          <p:spPr>
            <a:xfrm>
              <a:off x="3538855" y="487934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/>
            <p:cNvCxnSpPr/>
            <p:nvPr/>
          </p:nvCxnSpPr>
          <p:spPr>
            <a:xfrm>
              <a:off x="3853815" y="486918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连接符 40"/>
            <p:cNvCxnSpPr/>
            <p:nvPr/>
          </p:nvCxnSpPr>
          <p:spPr>
            <a:xfrm>
              <a:off x="4386580" y="4805680"/>
              <a:ext cx="323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接连接符 41"/>
            <p:cNvCxnSpPr/>
            <p:nvPr/>
          </p:nvCxnSpPr>
          <p:spPr>
            <a:xfrm>
              <a:off x="4391660" y="481076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连接符 42"/>
            <p:cNvCxnSpPr/>
            <p:nvPr/>
          </p:nvCxnSpPr>
          <p:spPr>
            <a:xfrm>
              <a:off x="4706620" y="480060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>
              <a:off x="5208905" y="4999355"/>
              <a:ext cx="323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/>
            <p:cNvCxnSpPr/>
            <p:nvPr/>
          </p:nvCxnSpPr>
          <p:spPr>
            <a:xfrm>
              <a:off x="5213985" y="5004435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46"/>
            <p:cNvCxnSpPr/>
            <p:nvPr/>
          </p:nvCxnSpPr>
          <p:spPr>
            <a:xfrm>
              <a:off x="5528945" y="4994275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连接符 48"/>
            <p:cNvCxnSpPr/>
            <p:nvPr/>
          </p:nvCxnSpPr>
          <p:spPr>
            <a:xfrm>
              <a:off x="7043420" y="4455160"/>
              <a:ext cx="323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连接符 49"/>
            <p:cNvCxnSpPr/>
            <p:nvPr/>
          </p:nvCxnSpPr>
          <p:spPr>
            <a:xfrm>
              <a:off x="7048500" y="446024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连接符 50"/>
            <p:cNvCxnSpPr/>
            <p:nvPr/>
          </p:nvCxnSpPr>
          <p:spPr>
            <a:xfrm>
              <a:off x="7363460" y="445008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接连接符 52"/>
            <p:cNvCxnSpPr/>
            <p:nvPr/>
          </p:nvCxnSpPr>
          <p:spPr>
            <a:xfrm>
              <a:off x="7881620" y="4653280"/>
              <a:ext cx="323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连接符 53"/>
            <p:cNvCxnSpPr/>
            <p:nvPr/>
          </p:nvCxnSpPr>
          <p:spPr>
            <a:xfrm>
              <a:off x="7886700" y="465836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连接符 54"/>
            <p:cNvCxnSpPr/>
            <p:nvPr/>
          </p:nvCxnSpPr>
          <p:spPr>
            <a:xfrm>
              <a:off x="8201660" y="464820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接连接符 56"/>
            <p:cNvCxnSpPr/>
            <p:nvPr/>
          </p:nvCxnSpPr>
          <p:spPr>
            <a:xfrm>
              <a:off x="8740140" y="4876800"/>
              <a:ext cx="323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接连接符 57"/>
            <p:cNvCxnSpPr/>
            <p:nvPr/>
          </p:nvCxnSpPr>
          <p:spPr>
            <a:xfrm>
              <a:off x="8745220" y="488188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连接符 58"/>
            <p:cNvCxnSpPr/>
            <p:nvPr/>
          </p:nvCxnSpPr>
          <p:spPr>
            <a:xfrm>
              <a:off x="9060180" y="487172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接连接符 60"/>
            <p:cNvCxnSpPr/>
            <p:nvPr/>
          </p:nvCxnSpPr>
          <p:spPr>
            <a:xfrm>
              <a:off x="9588500" y="4978400"/>
              <a:ext cx="323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接连接符 61"/>
            <p:cNvCxnSpPr/>
            <p:nvPr/>
          </p:nvCxnSpPr>
          <p:spPr>
            <a:xfrm>
              <a:off x="9593580" y="498348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接连接符 62"/>
            <p:cNvCxnSpPr/>
            <p:nvPr/>
          </p:nvCxnSpPr>
          <p:spPr>
            <a:xfrm>
              <a:off x="9908540" y="497332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接连接符 64"/>
            <p:cNvCxnSpPr/>
            <p:nvPr/>
          </p:nvCxnSpPr>
          <p:spPr>
            <a:xfrm>
              <a:off x="10426700" y="5059680"/>
              <a:ext cx="3238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连接符 65"/>
            <p:cNvCxnSpPr/>
            <p:nvPr/>
          </p:nvCxnSpPr>
          <p:spPr>
            <a:xfrm>
              <a:off x="10431780" y="506476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接连接符 66"/>
            <p:cNvCxnSpPr/>
            <p:nvPr/>
          </p:nvCxnSpPr>
          <p:spPr>
            <a:xfrm>
              <a:off x="10746740" y="5054600"/>
              <a:ext cx="0" cy="1079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文本框 73"/>
            <p:cNvSpPr txBox="1"/>
            <p:nvPr/>
          </p:nvSpPr>
          <p:spPr>
            <a:xfrm>
              <a:off x="2686050" y="4487545"/>
              <a:ext cx="55435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68" name="文本框 67"/>
            <p:cNvSpPr txBox="1"/>
            <p:nvPr/>
          </p:nvSpPr>
          <p:spPr>
            <a:xfrm>
              <a:off x="3486150" y="4671695"/>
              <a:ext cx="55435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69" name="文本框 68"/>
            <p:cNvSpPr txBox="1"/>
            <p:nvPr/>
          </p:nvSpPr>
          <p:spPr>
            <a:xfrm>
              <a:off x="4339590" y="4608830"/>
              <a:ext cx="55435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70" name="文本框 69"/>
            <p:cNvSpPr txBox="1"/>
            <p:nvPr/>
          </p:nvSpPr>
          <p:spPr>
            <a:xfrm>
              <a:off x="5178425" y="4792345"/>
              <a:ext cx="55435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71" name="文本框 70"/>
            <p:cNvSpPr txBox="1"/>
            <p:nvPr/>
          </p:nvSpPr>
          <p:spPr>
            <a:xfrm>
              <a:off x="7836535" y="4435475"/>
              <a:ext cx="55435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8687435" y="4667250"/>
              <a:ext cx="55435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9547225" y="4768850"/>
              <a:ext cx="55435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10380980" y="4857750"/>
              <a:ext cx="55435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7040880" y="4262755"/>
              <a:ext cx="55435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1988515" y="4280738"/>
              <a:ext cx="55435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EF68D98F-A9E9-43CF-8C5A-80FA1DE5536D}"/>
                </a:ext>
              </a:extLst>
            </p:cNvPr>
            <p:cNvCxnSpPr/>
            <p:nvPr/>
          </p:nvCxnSpPr>
          <p:spPr>
            <a:xfrm>
              <a:off x="1754505" y="3609181"/>
              <a:ext cx="567067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021E2897-5180-4417-AA69-81447B3F10AE}"/>
                </a:ext>
              </a:extLst>
            </p:cNvPr>
            <p:cNvSpPr txBox="1"/>
            <p:nvPr/>
          </p:nvSpPr>
          <p:spPr>
            <a:xfrm>
              <a:off x="1754505" y="3358779"/>
              <a:ext cx="60625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 cm</a:t>
              </a:r>
              <a:endParaRPr lang="zh-CN" alt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直接连接符 79">
              <a:extLst>
                <a:ext uri="{FF2B5EF4-FFF2-40B4-BE49-F238E27FC236}">
                  <a16:creationId xmlns:a16="http://schemas.microsoft.com/office/drawing/2014/main" id="{A9F97452-8326-415D-A86E-C5720C7FD6D4}"/>
                </a:ext>
              </a:extLst>
            </p:cNvPr>
            <p:cNvCxnSpPr/>
            <p:nvPr/>
          </p:nvCxnSpPr>
          <p:spPr>
            <a:xfrm>
              <a:off x="4140264" y="3587588"/>
              <a:ext cx="567067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276E7A2E-6590-40EE-A90D-A6BF6BD7104D}"/>
                </a:ext>
              </a:extLst>
            </p:cNvPr>
            <p:cNvSpPr txBox="1"/>
            <p:nvPr/>
          </p:nvSpPr>
          <p:spPr>
            <a:xfrm>
              <a:off x="4140264" y="3337186"/>
              <a:ext cx="60625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 cm</a:t>
              </a:r>
              <a:endParaRPr lang="zh-CN" alt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3" name="直接连接符 82">
              <a:extLst>
                <a:ext uri="{FF2B5EF4-FFF2-40B4-BE49-F238E27FC236}">
                  <a16:creationId xmlns:a16="http://schemas.microsoft.com/office/drawing/2014/main" id="{52295081-15C0-40E7-AF8B-A0F29165E3D2}"/>
                </a:ext>
              </a:extLst>
            </p:cNvPr>
            <p:cNvCxnSpPr/>
            <p:nvPr/>
          </p:nvCxnSpPr>
          <p:spPr>
            <a:xfrm>
              <a:off x="6599089" y="3566601"/>
              <a:ext cx="567067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386D2699-7152-4B40-A7AE-9AFE07A7ABCF}"/>
                </a:ext>
              </a:extLst>
            </p:cNvPr>
            <p:cNvSpPr txBox="1"/>
            <p:nvPr/>
          </p:nvSpPr>
          <p:spPr>
            <a:xfrm>
              <a:off x="6599089" y="3316199"/>
              <a:ext cx="60625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 cm</a:t>
              </a:r>
              <a:endParaRPr lang="zh-CN" alt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6" name="直接连接符 85">
              <a:extLst>
                <a:ext uri="{FF2B5EF4-FFF2-40B4-BE49-F238E27FC236}">
                  <a16:creationId xmlns:a16="http://schemas.microsoft.com/office/drawing/2014/main" id="{C69880AD-7C38-4576-91B5-09AE40A5EF55}"/>
                </a:ext>
              </a:extLst>
            </p:cNvPr>
            <p:cNvCxnSpPr/>
            <p:nvPr/>
          </p:nvCxnSpPr>
          <p:spPr>
            <a:xfrm>
              <a:off x="9031754" y="3570935"/>
              <a:ext cx="567067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7DF722DF-0186-4C2F-A5DD-2F571C4A87B4}"/>
                </a:ext>
              </a:extLst>
            </p:cNvPr>
            <p:cNvSpPr txBox="1"/>
            <p:nvPr/>
          </p:nvSpPr>
          <p:spPr>
            <a:xfrm>
              <a:off x="9031754" y="3320533"/>
              <a:ext cx="60625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 cm</a:t>
              </a:r>
              <a:endParaRPr lang="zh-CN" alt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9" name="直接连接符 88">
              <a:extLst>
                <a:ext uri="{FF2B5EF4-FFF2-40B4-BE49-F238E27FC236}">
                  <a16:creationId xmlns:a16="http://schemas.microsoft.com/office/drawing/2014/main" id="{18B4761A-F827-420C-BF38-27B962D920EB}"/>
                </a:ext>
              </a:extLst>
            </p:cNvPr>
            <p:cNvCxnSpPr/>
            <p:nvPr/>
          </p:nvCxnSpPr>
          <p:spPr>
            <a:xfrm>
              <a:off x="11490579" y="3576380"/>
              <a:ext cx="567067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91889ED7-F3C3-4861-8FE5-4B42C7222A87}"/>
                </a:ext>
              </a:extLst>
            </p:cNvPr>
            <p:cNvSpPr txBox="1"/>
            <p:nvPr/>
          </p:nvSpPr>
          <p:spPr>
            <a:xfrm>
              <a:off x="11490579" y="3325978"/>
              <a:ext cx="60625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 cm</a:t>
              </a:r>
              <a:endParaRPr lang="zh-CN" altLang="en-US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53</Words>
  <Application>Microsoft Office PowerPoint</Application>
  <PresentationFormat>自定义</PresentationFormat>
  <Paragraphs>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ang Sha</dc:creator>
  <cp:lastModifiedBy>Tang Sha</cp:lastModifiedBy>
  <cp:revision>20</cp:revision>
  <dcterms:created xsi:type="dcterms:W3CDTF">2021-07-03T03:45:00Z</dcterms:created>
  <dcterms:modified xsi:type="dcterms:W3CDTF">2021-07-15T06:14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74122F5BD08448EA104CB2858FDC7EA</vt:lpwstr>
  </property>
  <property fmtid="{D5CDD505-2E9C-101B-9397-08002B2CF9AE}" pid="3" name="KSOProductBuildVer">
    <vt:lpwstr>2052-11.1.0.10578</vt:lpwstr>
  </property>
</Properties>
</file>